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124" d="100"/>
          <a:sy n="124" d="100"/>
        </p:scale>
        <p:origin x="5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AA348-EC0A-5540-A696-93B0B6E08D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607420-3AE0-F746-988E-826851FDF4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6EEF76-E0CA-E34B-AE9A-40B1873C8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1C7974-CD36-CC40-B5D5-D02B3355E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B42A58-EB41-5746-8CCC-E2CE684EB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588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1FDCF-688A-B54E-B51B-D8A4803C86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1130E5-9250-B241-BC10-97EA945B30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159D37-1FBB-0A40-BF6C-C32419C4D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B39F16-ADD8-2646-9673-0A47AEB54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D3AC2D-1597-DA43-A0BE-601FFB866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79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39C2C4-17D3-4748-B78F-CC133FBC91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7605C2-F578-1543-AFFC-C5485B1800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A11002-46BC-3E4E-BF61-97073A2FC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AF06D-0FB1-6248-813E-F1E882F7E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0627EE-66FC-204C-A083-2EA1C6EF0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36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970107-814A-3341-AB3F-DAA672BEE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07707D-FC0D-7346-8CCB-67964BDADA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0B3510-1BB7-6F44-89E2-C93A95C16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6623C7-97FD-354B-ADC7-4CE6D606C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64124-48FB-044B-94C3-E2210D25B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21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942CD4-3A0F-ED4D-B3F5-55FCBC37F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F72A3A-A3C9-234A-BB47-99B5BDA54B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D54A35-99A3-644A-94D0-5AB4CBB76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447677-1739-ED4B-A918-B4FBC65AF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A574B2-BCF7-8549-B32F-16F08AD36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328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EFDB0-DBA4-A049-817F-56AF3B783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A284B3-6C57-4643-9B96-424D3C9C71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36BDB0-B882-3D4D-9D17-BEC3FE57B4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96EC34-D155-5847-A581-6DA41B532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26F64E-6757-2E4C-806C-C31A8BE5D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1899BA-6E0B-DC47-8850-2DB4DCF24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305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02D537-818D-7E42-8512-CD414F022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B3E09E-7293-AF49-8610-14DD371D14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E98047-9646-BF44-9BD7-244B67617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3466E7B-4F54-C044-ADC5-68E3D54C56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21042E-BE94-8F46-A310-7B0C31D783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A42F0A-B7A8-8E42-8B00-F6FFACC48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B33BE38-3D3F-C94C-85A1-CC4835881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D4BB64-42B9-3344-91F5-FD604108B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698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BEB6B3-71DE-DF48-B459-BEC575DED9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54E0CC-36AD-B140-9BB9-DECED8AE8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E721A2-C99C-E341-BB91-85B247A5B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7E6611-C384-7647-A476-B69AFB95C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253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18E913-54FF-194F-8B57-D69C568D2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895A0A-B71D-884B-BEC2-61FD34D89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AEB882-EFED-A24E-BF6E-27F67D03E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514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05190-D8C5-B44D-BD20-FAA951330D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ACB139-90B7-9A42-BC83-1A3DB54DBB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7A9509-BACE-E948-9017-A4F00E5EFD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747D59-01A0-1B42-9932-A32416C2F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6926A8-8749-0F46-90DE-EB470A1A3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E6E9D6-DDC8-CB42-8D26-B657BEA17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956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78550D-38F5-8C4A-B475-AA38F185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C2F5A7-5A60-574F-A481-B9A64EA5DC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585774-9DFC-394B-9978-3FFE6D5FC0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B76FC-4AA6-B549-8849-98187DF08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9B1C58-BB28-9D40-92C1-11EDA55327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318CCA-F239-2B4C-B9A0-0295CBF12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412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9D44A6-4586-FD4C-92AF-FB159A9C54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DE0591-B983-F746-830A-39D151C8E0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172F9-1F73-C04C-AE7F-29AEEEC958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7DBC2-FB74-1643-8657-A16D90124001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EEF3E6-3928-574B-8EE1-B82A4A5FA8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7592C3-2406-3542-82A7-9CC760B29A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1EA1A-2E56-CA44-B639-05929E07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510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F5ADD98-D45C-0F42-90D4-4D585379524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6687" b="2549"/>
          <a:stretch/>
        </p:blipFill>
        <p:spPr>
          <a:xfrm>
            <a:off x="1886408" y="3744949"/>
            <a:ext cx="3541673" cy="41840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E1D0CD3-447A-CA49-A624-B7FB602627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6406" y="4273659"/>
            <a:ext cx="3541674" cy="66053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4404828-72CA-184B-9166-269DF0500A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71381" y="3749849"/>
            <a:ext cx="3478619" cy="42144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B7AA000-9A2C-3842-BBD2-27D3EAEC81A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63998" y="4279539"/>
            <a:ext cx="3478617" cy="64877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91C91A4-A7D9-E54D-8467-F9CF4126C5A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63999" y="5042551"/>
            <a:ext cx="3478616" cy="38756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E989C47-4125-464F-916E-EABE14D9263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86407" y="5042551"/>
            <a:ext cx="3541673" cy="39458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276CB7DE-3520-E64F-8EA1-CDB4075B1A84}"/>
              </a:ext>
            </a:extLst>
          </p:cNvPr>
          <p:cNvSpPr txBox="1"/>
          <p:nvPr/>
        </p:nvSpPr>
        <p:spPr>
          <a:xfrm>
            <a:off x="145551" y="93456"/>
            <a:ext cx="12618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K-293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69B5940-65E2-CD40-8298-F81D18239814}"/>
              </a:ext>
            </a:extLst>
          </p:cNvPr>
          <p:cNvSpPr txBox="1"/>
          <p:nvPr/>
        </p:nvSpPr>
        <p:spPr>
          <a:xfrm>
            <a:off x="1752075" y="3172977"/>
            <a:ext cx="36760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  0       2       4      6       8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EAEAB4-5068-894D-9043-8BA31E243314}"/>
              </a:ext>
            </a:extLst>
          </p:cNvPr>
          <p:cNvSpPr txBox="1"/>
          <p:nvPr/>
        </p:nvSpPr>
        <p:spPr>
          <a:xfrm>
            <a:off x="5566611" y="3172976"/>
            <a:ext cx="35060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    0      2      4      6      8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FE187264-1FFB-1949-A3B4-40D825A5EC9B}"/>
              </a:ext>
            </a:extLst>
          </p:cNvPr>
          <p:cNvCxnSpPr>
            <a:cxnSpLocks/>
          </p:cNvCxnSpPr>
          <p:nvPr/>
        </p:nvCxnSpPr>
        <p:spPr>
          <a:xfrm>
            <a:off x="2130927" y="828214"/>
            <a:ext cx="1402914" cy="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6FA7B4CC-BBD1-F743-9F12-AD06F12EFF96}"/>
              </a:ext>
            </a:extLst>
          </p:cNvPr>
          <p:cNvCxnSpPr>
            <a:cxnSpLocks/>
          </p:cNvCxnSpPr>
          <p:nvPr/>
        </p:nvCxnSpPr>
        <p:spPr>
          <a:xfrm flipV="1">
            <a:off x="2122580" y="869615"/>
            <a:ext cx="0" cy="281258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74B27CA-4F35-CA4C-BB04-B9FEECC5F2AC}"/>
              </a:ext>
            </a:extLst>
          </p:cNvPr>
          <p:cNvCxnSpPr>
            <a:cxnSpLocks/>
          </p:cNvCxnSpPr>
          <p:nvPr/>
        </p:nvCxnSpPr>
        <p:spPr>
          <a:xfrm flipV="1">
            <a:off x="2433648" y="877035"/>
            <a:ext cx="0" cy="281258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65065EFF-A459-254D-AB4A-F1C4CFC785E2}"/>
              </a:ext>
            </a:extLst>
          </p:cNvPr>
          <p:cNvCxnSpPr>
            <a:cxnSpLocks/>
          </p:cNvCxnSpPr>
          <p:nvPr/>
        </p:nvCxnSpPr>
        <p:spPr>
          <a:xfrm flipV="1">
            <a:off x="2732180" y="870194"/>
            <a:ext cx="0" cy="281258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0E55DAE-8B5D-D34A-8426-602779331A96}"/>
              </a:ext>
            </a:extLst>
          </p:cNvPr>
          <p:cNvCxnSpPr>
            <a:cxnSpLocks/>
          </p:cNvCxnSpPr>
          <p:nvPr/>
        </p:nvCxnSpPr>
        <p:spPr>
          <a:xfrm flipV="1">
            <a:off x="3018191" y="877035"/>
            <a:ext cx="0" cy="281258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7C51E92D-1BFC-6B49-817A-81E8AB9E9319}"/>
              </a:ext>
            </a:extLst>
          </p:cNvPr>
          <p:cNvCxnSpPr>
            <a:cxnSpLocks/>
          </p:cNvCxnSpPr>
          <p:nvPr/>
        </p:nvCxnSpPr>
        <p:spPr>
          <a:xfrm flipV="1">
            <a:off x="3320904" y="869615"/>
            <a:ext cx="0" cy="281258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7F8D2561-3CAF-354D-8758-2952A60528ED}"/>
              </a:ext>
            </a:extLst>
          </p:cNvPr>
          <p:cNvCxnSpPr>
            <a:cxnSpLocks/>
          </p:cNvCxnSpPr>
          <p:nvPr/>
        </p:nvCxnSpPr>
        <p:spPr>
          <a:xfrm>
            <a:off x="2122580" y="454168"/>
            <a:ext cx="0" cy="281258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040191-82CF-C64E-9B02-B47C2C8A3212}"/>
              </a:ext>
            </a:extLst>
          </p:cNvPr>
          <p:cNvSpPr txBox="1"/>
          <p:nvPr/>
        </p:nvSpPr>
        <p:spPr>
          <a:xfrm>
            <a:off x="1736095" y="9345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9E2F908-3969-904A-B366-1EB1416698E9}"/>
              </a:ext>
            </a:extLst>
          </p:cNvPr>
          <p:cNvSpPr txBox="1"/>
          <p:nvPr/>
        </p:nvSpPr>
        <p:spPr>
          <a:xfrm>
            <a:off x="2242302" y="1158293"/>
            <a:ext cx="979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arvest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181F3757-7909-E44D-B4D9-4262563B35E4}"/>
              </a:ext>
            </a:extLst>
          </p:cNvPr>
          <p:cNvCxnSpPr>
            <a:cxnSpLocks/>
          </p:cNvCxnSpPr>
          <p:nvPr/>
        </p:nvCxnSpPr>
        <p:spPr>
          <a:xfrm>
            <a:off x="1886408" y="3094690"/>
            <a:ext cx="3617573" cy="0"/>
          </a:xfrm>
          <a:prstGeom prst="straightConnector1">
            <a:avLst/>
          </a:prstGeom>
          <a:ln w="50800">
            <a:solidFill>
              <a:schemeClr val="tx1"/>
            </a:solidFill>
            <a:round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C0F951EC-8FC4-2145-81C2-DA9CA0DA0F12}"/>
              </a:ext>
            </a:extLst>
          </p:cNvPr>
          <p:cNvCxnSpPr>
            <a:cxnSpLocks/>
          </p:cNvCxnSpPr>
          <p:nvPr/>
        </p:nvCxnSpPr>
        <p:spPr>
          <a:xfrm>
            <a:off x="5700944" y="3094690"/>
            <a:ext cx="3617573" cy="0"/>
          </a:xfrm>
          <a:prstGeom prst="straightConnector1">
            <a:avLst/>
          </a:prstGeom>
          <a:ln w="50800">
            <a:solidFill>
              <a:schemeClr val="tx1"/>
            </a:solidFill>
            <a:round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E22985E-5CCB-5546-B7E5-467508021EA0}"/>
              </a:ext>
            </a:extLst>
          </p:cNvPr>
          <p:cNvSpPr txBox="1"/>
          <p:nvPr/>
        </p:nvSpPr>
        <p:spPr>
          <a:xfrm>
            <a:off x="-93695" y="3798612"/>
            <a:ext cx="195598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NAPII pSer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1368ECC-00AE-0C42-912B-DBBA65DF8DD3}"/>
              </a:ext>
            </a:extLst>
          </p:cNvPr>
          <p:cNvSpPr txBox="1"/>
          <p:nvPr/>
        </p:nvSpPr>
        <p:spPr>
          <a:xfrm>
            <a:off x="567327" y="5005499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1A01F85-B70D-5344-9792-8A44DE724830}"/>
              </a:ext>
            </a:extLst>
          </p:cNvPr>
          <p:cNvSpPr txBox="1"/>
          <p:nvPr/>
        </p:nvSpPr>
        <p:spPr>
          <a:xfrm>
            <a:off x="3234172" y="2484259"/>
            <a:ext cx="9220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5D6F9D8-B84A-FD45-BED1-806EC49DF6BB}"/>
              </a:ext>
            </a:extLst>
          </p:cNvPr>
          <p:cNvSpPr txBox="1"/>
          <p:nvPr/>
        </p:nvSpPr>
        <p:spPr>
          <a:xfrm>
            <a:off x="6698451" y="2484259"/>
            <a:ext cx="16225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K-293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B04CFB9-7E5B-7B48-83A8-DDE5AFCB0DC4}"/>
              </a:ext>
            </a:extLst>
          </p:cNvPr>
          <p:cNvSpPr txBox="1"/>
          <p:nvPr/>
        </p:nvSpPr>
        <p:spPr>
          <a:xfrm>
            <a:off x="295864" y="2881928"/>
            <a:ext cx="168988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0nM </a:t>
            </a:r>
          </a:p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 (hr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6D51B75-9D4C-564E-97B5-45B6B0D3C8CA}"/>
              </a:ext>
            </a:extLst>
          </p:cNvPr>
          <p:cNvSpPr txBox="1"/>
          <p:nvPr/>
        </p:nvSpPr>
        <p:spPr>
          <a:xfrm>
            <a:off x="567327" y="4363678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CE79AE96-18B9-394B-AD70-37DA8E9EF40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450841" y="3713259"/>
            <a:ext cx="2744611" cy="30461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30ADC62B-50D9-F643-8D19-A97CC7A527A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463936" y="81228"/>
            <a:ext cx="2728064" cy="334777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2865312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EC0CA15-4A97-604F-B568-CFD3913B87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15906" y="2862153"/>
            <a:ext cx="5751071" cy="41397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578113B-3700-7743-BDF4-DB4B24284C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15907" y="338246"/>
            <a:ext cx="5751072" cy="252390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7CBBEFC-779B-0E49-A54A-FCB84C09B61A}"/>
              </a:ext>
            </a:extLst>
          </p:cNvPr>
          <p:cNvSpPr txBox="1"/>
          <p:nvPr/>
        </p:nvSpPr>
        <p:spPr>
          <a:xfrm>
            <a:off x="1914451" y="491073"/>
            <a:ext cx="17588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97C602-34B9-1747-B490-3B053EFCFDCA}"/>
              </a:ext>
            </a:extLst>
          </p:cNvPr>
          <p:cNvSpPr txBox="1"/>
          <p:nvPr/>
        </p:nvSpPr>
        <p:spPr>
          <a:xfrm>
            <a:off x="2132651" y="3849010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82EA053-E575-9043-B29F-B65AEAB0B3B5}"/>
              </a:ext>
            </a:extLst>
          </p:cNvPr>
          <p:cNvSpPr txBox="1"/>
          <p:nvPr/>
        </p:nvSpPr>
        <p:spPr>
          <a:xfrm>
            <a:off x="418385" y="0"/>
            <a:ext cx="9220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C6972C5-6028-6C4F-8C4F-3880620C535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204"/>
          <a:stretch/>
        </p:blipFill>
        <p:spPr>
          <a:xfrm>
            <a:off x="10274157" y="1746250"/>
            <a:ext cx="1104686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60404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9EDCAA6-6E7C-1548-9EA0-1CADE0A53F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7631" y="3429000"/>
            <a:ext cx="7200900" cy="3111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14987F0-8EFC-0C4F-AE81-817418F1F4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7631" y="223099"/>
            <a:ext cx="7200900" cy="298787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F5A051E-1D0E-A94D-87BD-96915C9BDB2B}"/>
              </a:ext>
            </a:extLst>
          </p:cNvPr>
          <p:cNvSpPr txBox="1"/>
          <p:nvPr/>
        </p:nvSpPr>
        <p:spPr>
          <a:xfrm>
            <a:off x="1067017" y="1156009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4A1C74-4164-1343-ADA7-6B3CAA4F51B3}"/>
              </a:ext>
            </a:extLst>
          </p:cNvPr>
          <p:cNvSpPr txBox="1"/>
          <p:nvPr/>
        </p:nvSpPr>
        <p:spPr>
          <a:xfrm>
            <a:off x="1330170" y="4529561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BA76F6-3EE1-5148-BE78-2C161285D8DA}"/>
              </a:ext>
            </a:extLst>
          </p:cNvPr>
          <p:cNvSpPr txBox="1"/>
          <p:nvPr/>
        </p:nvSpPr>
        <p:spPr>
          <a:xfrm>
            <a:off x="232157" y="82194"/>
            <a:ext cx="9220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60425D6-FC5D-E349-8323-0378E5AA7AA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204"/>
          <a:stretch/>
        </p:blipFill>
        <p:spPr>
          <a:xfrm>
            <a:off x="10274157" y="1746250"/>
            <a:ext cx="1104686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57977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87E1C58-DF9C-874E-88D7-3CB19D463E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2560" y="984007"/>
            <a:ext cx="3878721" cy="166018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0F55D1C-38F2-C347-AEE4-B202EB4E53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V="1">
            <a:off x="4532560" y="2644189"/>
            <a:ext cx="3895148" cy="404977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255C609-5CF9-BF46-A027-92EEF1CF1B88}"/>
              </a:ext>
            </a:extLst>
          </p:cNvPr>
          <p:cNvSpPr txBox="1"/>
          <p:nvPr/>
        </p:nvSpPr>
        <p:spPr>
          <a:xfrm>
            <a:off x="2541175" y="984007"/>
            <a:ext cx="17588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9ED7AB2-751D-EE44-9F5D-09507B1A0184}"/>
              </a:ext>
            </a:extLst>
          </p:cNvPr>
          <p:cNvSpPr txBox="1"/>
          <p:nvPr/>
        </p:nvSpPr>
        <p:spPr>
          <a:xfrm>
            <a:off x="2954584" y="3429000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749236F-3B11-1B41-8E4D-8F3A580CFDB9}"/>
              </a:ext>
            </a:extLst>
          </p:cNvPr>
          <p:cNvSpPr txBox="1"/>
          <p:nvPr/>
        </p:nvSpPr>
        <p:spPr>
          <a:xfrm>
            <a:off x="192354" y="71919"/>
            <a:ext cx="9220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E1B203A-B291-DC44-92A4-673A5A37A99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204"/>
          <a:stretch/>
        </p:blipFill>
        <p:spPr>
          <a:xfrm>
            <a:off x="10274157" y="1746250"/>
            <a:ext cx="1104686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95848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D61E7DB-CE94-E247-80CE-A02B3BF370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6727" y="3429000"/>
            <a:ext cx="4116419" cy="294814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0FA91D5-7AE1-5B45-9AE1-DA5FB05FDE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4374" y="1838553"/>
            <a:ext cx="4225534" cy="136410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57447CA-242A-B445-AF21-DA380B1AADAA}"/>
              </a:ext>
            </a:extLst>
          </p:cNvPr>
          <p:cNvSpPr txBox="1"/>
          <p:nvPr/>
        </p:nvSpPr>
        <p:spPr>
          <a:xfrm>
            <a:off x="3483787" y="3792838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78B3459-8588-7E41-9B71-94B45F435C2D}"/>
              </a:ext>
            </a:extLst>
          </p:cNvPr>
          <p:cNvSpPr txBox="1"/>
          <p:nvPr/>
        </p:nvSpPr>
        <p:spPr>
          <a:xfrm>
            <a:off x="3465223" y="1838553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85C1C53-B727-2041-9D1B-4E8ED2F6BC22}"/>
              </a:ext>
            </a:extLst>
          </p:cNvPr>
          <p:cNvSpPr txBox="1"/>
          <p:nvPr/>
        </p:nvSpPr>
        <p:spPr>
          <a:xfrm>
            <a:off x="295095" y="174661"/>
            <a:ext cx="9220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4A58F8B-CFEF-134B-B790-D4AD8A5D2AC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204"/>
          <a:stretch/>
        </p:blipFill>
        <p:spPr>
          <a:xfrm>
            <a:off x="10274157" y="1746250"/>
            <a:ext cx="1104686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9253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4</TotalTime>
  <Words>42</Words>
  <Application>Microsoft Macintosh PowerPoint</Application>
  <PresentationFormat>Widescreen</PresentationFormat>
  <Paragraphs>2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7</cp:revision>
  <dcterms:created xsi:type="dcterms:W3CDTF">2019-07-17T21:19:20Z</dcterms:created>
  <dcterms:modified xsi:type="dcterms:W3CDTF">2019-11-24T21:12:17Z</dcterms:modified>
</cp:coreProperties>
</file>